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8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7" y="5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121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310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448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500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451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07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792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833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792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266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013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F8EB4-9BA6-4FD2-BA0C-780DD29ABBB0}" type="datetimeFigureOut">
              <a:rPr lang="en-US" smtClean="0"/>
              <a:t>10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46611-5D22-4F31-A2BE-21B8E94859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61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tiff"/><Relationship Id="rId4" Type="http://schemas.openxmlformats.org/officeDocument/2006/relationships/image" Target="../media/image6.png"/><Relationship Id="rId9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9000" contrast="47000"/>
                    </a14:imgEffect>
                  </a14:imgLayer>
                </a14:imgProps>
              </a:ext>
            </a:extLst>
          </a:blip>
          <a:srcRect l="4418" r="1435"/>
          <a:stretch/>
        </p:blipFill>
        <p:spPr>
          <a:xfrm>
            <a:off x="7219752" y="1706915"/>
            <a:ext cx="2522795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4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909" t="32274" r="1" b="-1"/>
          <a:stretch/>
        </p:blipFill>
        <p:spPr>
          <a:xfrm>
            <a:off x="2341775" y="1706915"/>
            <a:ext cx="2439635" cy="27432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0000"/>
                    </a14:imgEffect>
                    <a14:imgEffect>
                      <a14:brightnessContrast bright="41000" contrast="-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58" t="31207" r="1" b="1"/>
          <a:stretch/>
        </p:blipFill>
        <p:spPr>
          <a:xfrm>
            <a:off x="4879676" y="1706915"/>
            <a:ext cx="2317647" cy="27432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814949" y="1398747"/>
            <a:ext cx="14932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312063" y="1398747"/>
            <a:ext cx="13770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totraker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838385" y="1398747"/>
            <a:ext cx="14932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201228" y="377613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6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1411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26128" t="7935" r="26671" b="7500"/>
          <a:stretch/>
        </p:blipFill>
        <p:spPr>
          <a:xfrm>
            <a:off x="6193368" y="3962631"/>
            <a:ext cx="2743200" cy="2743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26325" t="8261" r="26351" b="8044"/>
          <a:stretch/>
        </p:blipFill>
        <p:spPr>
          <a:xfrm>
            <a:off x="558902" y="3962631"/>
            <a:ext cx="2743200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26291" t="8479" r="26386" b="7392"/>
          <a:stretch/>
        </p:blipFill>
        <p:spPr>
          <a:xfrm>
            <a:off x="3351014" y="3962631"/>
            <a:ext cx="2743200" cy="27432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701305" y="3648177"/>
            <a:ext cx="1729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totraker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81277" y="3681754"/>
            <a:ext cx="1729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397748" y="3681754"/>
            <a:ext cx="1729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5480" y="3962631"/>
            <a:ext cx="2743200" cy="27432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/>
          <a:srcRect l="26291" t="8370" r="26474" b="7881"/>
          <a:stretch/>
        </p:blipFill>
        <p:spPr>
          <a:xfrm>
            <a:off x="3352344" y="991504"/>
            <a:ext cx="2743200" cy="27432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/>
          <a:srcRect l="26142" t="9620" r="26657" b="7554"/>
          <a:stretch/>
        </p:blipFill>
        <p:spPr>
          <a:xfrm>
            <a:off x="533613" y="991504"/>
            <a:ext cx="2743200" cy="27432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8"/>
          <a:srcRect l="26426" t="8088" r="26250" b="8651"/>
          <a:stretch/>
        </p:blipFill>
        <p:spPr>
          <a:xfrm>
            <a:off x="6144456" y="991504"/>
            <a:ext cx="2743200" cy="27432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822608" y="697588"/>
            <a:ext cx="21058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-3XFla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059397" y="697588"/>
            <a:ext cx="1729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-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006874" y="697588"/>
            <a:ext cx="1729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241021" y="697588"/>
            <a:ext cx="17294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568" y="991504"/>
            <a:ext cx="2752299" cy="27432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856425" y="3681754"/>
            <a:ext cx="21058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-3XFla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66565" y="120862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6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6026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04" t="32158" r="17793" b="26489"/>
          <a:stretch/>
        </p:blipFill>
        <p:spPr>
          <a:xfrm>
            <a:off x="3058188" y="1640589"/>
            <a:ext cx="5837382" cy="295845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5740069" y="2734214"/>
            <a:ext cx="1114266" cy="313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7" name="TextBox 6"/>
          <p:cNvSpPr txBox="1"/>
          <p:nvPr/>
        </p:nvSpPr>
        <p:spPr>
          <a:xfrm>
            <a:off x="5740069" y="2364882"/>
            <a:ext cx="8659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DAC1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7228504" y="2143670"/>
            <a:ext cx="1114266" cy="313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9" name="TextBox 8"/>
          <p:cNvSpPr txBox="1"/>
          <p:nvPr/>
        </p:nvSpPr>
        <p:spPr>
          <a:xfrm>
            <a:off x="7262268" y="1791823"/>
            <a:ext cx="10346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553683" y="211556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44448" y="182880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101972" y="249449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117541" y="300202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08031" y="309535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787358" y="340533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7228504" y="3214796"/>
            <a:ext cx="1114266" cy="313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7" name="TextBox 16"/>
          <p:cNvSpPr txBox="1"/>
          <p:nvPr/>
        </p:nvSpPr>
        <p:spPr>
          <a:xfrm>
            <a:off x="7273926" y="2919211"/>
            <a:ext cx="1083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767687" y="3774663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228504" y="3780532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247496" y="3011991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722895" y="3002024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732092" y="2455637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192909" y="2461506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201228" y="377613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6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964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94" r="12451" b="29860"/>
          <a:stretch/>
        </p:blipFill>
        <p:spPr>
          <a:xfrm>
            <a:off x="7019913" y="1486290"/>
            <a:ext cx="4203011" cy="299127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742" t="11684" r="17739" b="47079"/>
          <a:stretch/>
        </p:blipFill>
        <p:spPr>
          <a:xfrm>
            <a:off x="802183" y="1559616"/>
            <a:ext cx="5872899" cy="282804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94935" y="218178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894935" y="330188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894935" y="258545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94935" y="355641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370767" y="383232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738632" y="2087518"/>
            <a:ext cx="2163453" cy="4979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3" name="Rectangle 12"/>
          <p:cNvSpPr/>
          <p:nvPr/>
        </p:nvSpPr>
        <p:spPr>
          <a:xfrm>
            <a:off x="8998766" y="3167897"/>
            <a:ext cx="1548661" cy="2683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4" name="Rectangle 13"/>
          <p:cNvSpPr/>
          <p:nvPr/>
        </p:nvSpPr>
        <p:spPr>
          <a:xfrm>
            <a:off x="1042567" y="3768020"/>
            <a:ext cx="2163453" cy="4979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5" name="TextBox 14"/>
          <p:cNvSpPr txBox="1"/>
          <p:nvPr/>
        </p:nvSpPr>
        <p:spPr>
          <a:xfrm>
            <a:off x="4599785" y="1718186"/>
            <a:ext cx="8170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TP5B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9133080" y="2817392"/>
            <a:ext cx="1083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78941" y="3301888"/>
            <a:ext cx="8654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OM2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34306" y="4292896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23631" y="4312483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107338" y="4312483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674198" y="4308285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0197994" y="3754082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9795799" y="3762994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9405023" y="3762994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028476" y="376299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374695" y="2614722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884995" y="2604039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28432" y="2614722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770698" y="2614722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190997" y="4793855"/>
            <a:ext cx="1576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726116" y="4668276"/>
            <a:ext cx="14718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3775082" y="3601366"/>
            <a:ext cx="2045394" cy="338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42" name="TextBox 41"/>
          <p:cNvSpPr txBox="1"/>
          <p:nvPr/>
        </p:nvSpPr>
        <p:spPr>
          <a:xfrm>
            <a:off x="4155307" y="3258356"/>
            <a:ext cx="1083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AM210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464381" y="3967887"/>
            <a:ext cx="606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924896" y="3975705"/>
            <a:ext cx="572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372156" y="3975705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793406" y="394828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201228" y="377613"/>
            <a:ext cx="1687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6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6731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64</Words>
  <Application>Microsoft Office PowerPoint</Application>
  <PresentationFormat>Widescreen</PresentationFormat>
  <Paragraphs>5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Jiangbin</dc:creator>
  <cp:lastModifiedBy>Wu, Jiangbin</cp:lastModifiedBy>
  <cp:revision>12</cp:revision>
  <dcterms:created xsi:type="dcterms:W3CDTF">2020-10-20T18:29:31Z</dcterms:created>
  <dcterms:modified xsi:type="dcterms:W3CDTF">2020-10-29T16:11:38Z</dcterms:modified>
</cp:coreProperties>
</file>